
<file path=[Content_Types].xml><?xml version="1.0" encoding="utf-8"?>
<Types xmlns="http://schemas.openxmlformats.org/package/2006/content-types">
  <Default Extension="png" ContentType="image/png"/>
  <Default Extension="tmp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7" r:id="rId2"/>
    <p:sldId id="258" r:id="rId3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150" d="100"/>
          <a:sy n="150" d="100"/>
        </p:scale>
        <p:origin x="586" y="-4973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5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3027B7-F8B6-4D61-8BE6-521A7E8EC852}" type="datetimeFigureOut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3/18/2019</a:t>
            </a:fld>
            <a:endParaRPr lang="en-US" dirty="0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87B6CB-375F-4958-97B5-6E64931E30AC}" type="slidenum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‹#›</a:t>
            </a:fld>
            <a:endParaRPr lang="en-US" dirty="0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39213691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3027B7-F8B6-4D61-8BE6-521A7E8EC852}" type="datetimeFigureOut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3/18/2019</a:t>
            </a:fld>
            <a:endParaRPr lang="en-US" dirty="0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87B6CB-375F-4958-97B5-6E64931E30AC}" type="slidenum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‹#›</a:t>
            </a:fld>
            <a:endParaRPr lang="en-US" dirty="0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37554666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8" y="486835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9" y="486835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3027B7-F8B6-4D61-8BE6-521A7E8EC852}" type="datetimeFigureOut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3/18/2019</a:t>
            </a:fld>
            <a:endParaRPr lang="en-US" dirty="0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87B6CB-375F-4958-97B5-6E64931E30AC}" type="slidenum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‹#›</a:t>
            </a:fld>
            <a:endParaRPr lang="en-US" dirty="0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10314827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3027B7-F8B6-4D61-8BE6-521A7E8EC852}" type="datetimeFigureOut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3/18/2019</a:t>
            </a:fld>
            <a:endParaRPr lang="en-US" dirty="0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87B6CB-375F-4958-97B5-6E64931E30AC}" type="slidenum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‹#›</a:t>
            </a:fld>
            <a:endParaRPr lang="en-US" dirty="0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2980198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7" y="2279654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7" y="6119288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3027B7-F8B6-4D61-8BE6-521A7E8EC852}" type="datetimeFigureOut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3/18/2019</a:t>
            </a:fld>
            <a:endParaRPr lang="en-US" dirty="0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87B6CB-375F-4958-97B5-6E64931E30AC}" type="slidenum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‹#›</a:t>
            </a:fld>
            <a:endParaRPr lang="en-US" dirty="0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14446409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3027B7-F8B6-4D61-8BE6-521A7E8EC852}" type="datetimeFigureOut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3/18/2019</a:t>
            </a:fld>
            <a:endParaRPr lang="en-US" dirty="0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87B6CB-375F-4958-97B5-6E64931E30AC}" type="slidenum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‹#›</a:t>
            </a:fld>
            <a:endParaRPr lang="en-US" dirty="0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1043138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486837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2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241552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3027B7-F8B6-4D61-8BE6-521A7E8EC852}" type="datetimeFigureOut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3/18/2019</a:t>
            </a:fld>
            <a:endParaRPr lang="en-US" dirty="0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87B6CB-375F-4958-97B5-6E64931E30AC}" type="slidenum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‹#›</a:t>
            </a:fld>
            <a:endParaRPr lang="en-US" dirty="0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35164567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3027B7-F8B6-4D61-8BE6-521A7E8EC852}" type="datetimeFigureOut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3/18/2019</a:t>
            </a:fld>
            <a:endParaRPr lang="en-US" dirty="0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87B6CB-375F-4958-97B5-6E64931E30AC}" type="slidenum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‹#›</a:t>
            </a:fld>
            <a:endParaRPr lang="en-US" dirty="0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4659445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3027B7-F8B6-4D61-8BE6-521A7E8EC852}" type="datetimeFigureOut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3/18/2019</a:t>
            </a:fld>
            <a:endParaRPr lang="en-US" dirty="0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87B6CB-375F-4958-97B5-6E64931E30AC}" type="slidenum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‹#›</a:t>
            </a:fld>
            <a:endParaRPr lang="en-US" dirty="0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36842207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4" y="1316570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3027B7-F8B6-4D61-8BE6-521A7E8EC852}" type="datetimeFigureOut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3/18/2019</a:t>
            </a:fld>
            <a:endParaRPr lang="en-US" dirty="0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87B6CB-375F-4958-97B5-6E64931E30AC}" type="slidenum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‹#›</a:t>
            </a:fld>
            <a:endParaRPr lang="en-US" dirty="0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9619596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4" y="1316570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dirty="0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3027B7-F8B6-4D61-8BE6-521A7E8EC852}" type="datetimeFigureOut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3/18/2019</a:t>
            </a:fld>
            <a:endParaRPr lang="en-US" dirty="0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87B6CB-375F-4958-97B5-6E64931E30AC}" type="slidenum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‹#›</a:t>
            </a:fld>
            <a:endParaRPr lang="en-US" dirty="0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18531634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7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7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defTabSz="914400"/>
            <a:fld id="{4F3027B7-F8B6-4D61-8BE6-521A7E8EC852}" type="datetimeFigureOut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 defTabSz="914400"/>
              <a:t>3/18/2019</a:t>
            </a:fld>
            <a:endParaRPr lang="en-US" dirty="0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7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defTabSz="914400"/>
            <a:endParaRPr lang="en-US" dirty="0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7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defTabSz="914400"/>
            <a:fld id="{8F87B6CB-375F-4958-97B5-6E64931E30AC}" type="slidenum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 defTabSz="914400"/>
              <a:t>‹#›</a:t>
            </a:fld>
            <a:endParaRPr lang="en-US" dirty="0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4311977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png"/><Relationship Id="rId3" Type="http://schemas.openxmlformats.org/officeDocument/2006/relationships/image" Target="../media/image4.png"/><Relationship Id="rId7" Type="http://schemas.openxmlformats.org/officeDocument/2006/relationships/image" Target="../media/image8.png"/><Relationship Id="rId2" Type="http://schemas.openxmlformats.org/officeDocument/2006/relationships/image" Target="../media/image3.tmp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.png"/><Relationship Id="rId5" Type="http://schemas.openxmlformats.org/officeDocument/2006/relationships/image" Target="../media/image6.png"/><Relationship Id="rId4" Type="http://schemas.openxmlformats.org/officeDocument/2006/relationships/image" Target="../media/image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52826" y="311551"/>
            <a:ext cx="3282512" cy="2876183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="" xmlns:a16="http://schemas.microsoft.com/office/drawing/2014/main" id="{DAFBECD2-05B0-4C95-882D-E9EE8E19AA2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" y="13755"/>
            <a:ext cx="3594079" cy="3683931"/>
          </a:xfrm>
          <a:prstGeom prst="rect">
            <a:avLst/>
          </a:prstGeom>
        </p:spPr>
      </p:pic>
      <p:sp>
        <p:nvSpPr>
          <p:cNvPr id="2" name="Rectangle 1"/>
          <p:cNvSpPr/>
          <p:nvPr/>
        </p:nvSpPr>
        <p:spPr>
          <a:xfrm>
            <a:off x="0" y="3697686"/>
            <a:ext cx="6858000" cy="181588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/>
              <a:t>Supplemental Figure 1: </a:t>
            </a:r>
            <a:r>
              <a:rPr lang="en-US" sz="1400" b="1" dirty="0" err="1"/>
              <a:t>obASCs</a:t>
            </a:r>
            <a:r>
              <a:rPr lang="en-US" sz="1400" b="1" dirty="0"/>
              <a:t> promote tumor growth and metastasis of WT ER+BC. </a:t>
            </a:r>
            <a:endParaRPr lang="en-US" sz="1400" dirty="0"/>
          </a:p>
          <a:p>
            <a:r>
              <a:rPr lang="en-US" sz="1400" dirty="0"/>
              <a:t>ER WT </a:t>
            </a:r>
            <a:r>
              <a:rPr lang="en-US" sz="1400" dirty="0" err="1"/>
              <a:t>xenograft</a:t>
            </a:r>
            <a:r>
              <a:rPr lang="en-US" sz="1400" dirty="0"/>
              <a:t> volume (MFC7) did not grow without estrogen pellets even in the presence of </a:t>
            </a:r>
            <a:r>
              <a:rPr lang="en-US" sz="1400" dirty="0" err="1"/>
              <a:t>obASCs</a:t>
            </a:r>
            <a:r>
              <a:rPr lang="en-US" sz="1400" dirty="0"/>
              <a:t>. MCF7 </a:t>
            </a:r>
            <a:r>
              <a:rPr lang="en-US" sz="1400" dirty="0" err="1"/>
              <a:t>xenografts</a:t>
            </a:r>
            <a:r>
              <a:rPr lang="en-US" sz="1400" dirty="0"/>
              <a:t> with estrogen had significantly increased tumor volume if grown in the presence of </a:t>
            </a:r>
            <a:r>
              <a:rPr lang="en-US" sz="1400" dirty="0" err="1"/>
              <a:t>obASCs</a:t>
            </a:r>
            <a:r>
              <a:rPr lang="en-US" sz="1400" dirty="0"/>
              <a:t>. Evaluation of metastasis revealed increased metastatic index (percent area of lungs occupied my metastasis) of MCF7 tumors grown with </a:t>
            </a:r>
            <a:r>
              <a:rPr lang="en-US" sz="1400" dirty="0" err="1"/>
              <a:t>obASCs</a:t>
            </a:r>
            <a:r>
              <a:rPr lang="en-US" sz="1400" dirty="0"/>
              <a:t> with and without estrogen pellets. Caliper measurements were taken every three to four days until tumor volume reached </a:t>
            </a:r>
            <a:r>
              <a:rPr lang="en-US" sz="1400" dirty="0" smtClean="0"/>
              <a:t>750–1000 </a:t>
            </a:r>
            <a:r>
              <a:rPr lang="en-US" sz="1400" dirty="0"/>
              <a:t>mm</a:t>
            </a:r>
            <a:r>
              <a:rPr lang="en-US" sz="1400" baseline="30000" dirty="0"/>
              <a:t>3</a:t>
            </a:r>
            <a:r>
              <a:rPr lang="en-US" sz="1400" dirty="0"/>
              <a:t>. Values reported are the mean (</a:t>
            </a:r>
            <a:r>
              <a:rPr lang="en-US" sz="1400" dirty="0" smtClean="0"/>
              <a:t>n = 5 </a:t>
            </a:r>
            <a:r>
              <a:rPr lang="en-US" sz="1400" dirty="0"/>
              <a:t>mice/group). Bars, ± SEM. *p&lt;0.05, ** p&lt;0.01, ***p&lt;0.001. </a:t>
            </a:r>
          </a:p>
        </p:txBody>
      </p:sp>
    </p:spTree>
    <p:extLst>
      <p:ext uri="{BB962C8B-B14F-4D97-AF65-F5344CB8AC3E}">
        <p14:creationId xmlns:p14="http://schemas.microsoft.com/office/powerpoint/2010/main" val="310932675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Picture 10" descr="Screen Clipping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42209" b="58254"/>
          <a:stretch/>
        </p:blipFill>
        <p:spPr>
          <a:xfrm>
            <a:off x="38103" y="4589912"/>
            <a:ext cx="2266949" cy="1795315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 rotWithShape="1">
          <a:blip r:embed="rId3"/>
          <a:srcRect t="57476" r="42243"/>
          <a:stretch/>
        </p:blipFill>
        <p:spPr>
          <a:xfrm>
            <a:off x="2305052" y="4572002"/>
            <a:ext cx="2266949" cy="1829569"/>
          </a:xfrm>
          <a:prstGeom prst="rect">
            <a:avLst/>
          </a:prstGeom>
        </p:spPr>
      </p:pic>
      <p:pic>
        <p:nvPicPr>
          <p:cNvPr id="2" name="Picture 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15428" y="-32618"/>
            <a:ext cx="2875695" cy="2670793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438525" y="1"/>
            <a:ext cx="3138294" cy="2631027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85288" y="2620260"/>
            <a:ext cx="2880909" cy="2055048"/>
          </a:xfrm>
          <a:prstGeom prst="rect">
            <a:avLst/>
          </a:prstGeom>
        </p:spPr>
      </p:pic>
      <p:pic>
        <p:nvPicPr>
          <p:cNvPr id="8" name="Picture 7" descr="Screen Clipping">
            <a:extLst>
              <a:ext uri="{FF2B5EF4-FFF2-40B4-BE49-F238E27FC236}">
                <a16:creationId xmlns="" xmlns:a16="http://schemas.microsoft.com/office/drawing/2014/main" id="{B5032778-25CB-4901-A954-817E7B175FA9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7256" t="9155" r="4280" b="80184"/>
          <a:stretch/>
        </p:blipFill>
        <p:spPr>
          <a:xfrm>
            <a:off x="4638675" y="5251288"/>
            <a:ext cx="1880773" cy="571501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="" xmlns:a16="http://schemas.microsoft.com/office/drawing/2014/main" id="{ED782827-E1B4-460C-B733-0C6326B34950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690651" y="2631028"/>
            <a:ext cx="2710151" cy="2180661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="" xmlns:a16="http://schemas.microsoft.com/office/drawing/2014/main" id="{DD36D002-3F3A-4767-B85D-6C9BCDF664D6}"/>
              </a:ext>
            </a:extLst>
          </p:cNvPr>
          <p:cNvSpPr txBox="1"/>
          <p:nvPr/>
        </p:nvSpPr>
        <p:spPr>
          <a:xfrm>
            <a:off x="994217" y="149840"/>
            <a:ext cx="56942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/>
            <a:r>
              <a:rPr lang="en-US" dirty="0">
                <a:solidFill>
                  <a:prstClr val="black"/>
                </a:solidFill>
                <a:latin typeface="Calibri"/>
              </a:rPr>
              <a:t>MCF7 Y537S 			WHIM20 PDX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="" xmlns:a16="http://schemas.microsoft.com/office/drawing/2014/main" id="{F3E1DC0A-D5AF-47A5-B8C2-3B87CE56C21F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13185" t="83146" b="241"/>
          <a:stretch/>
        </p:blipFill>
        <p:spPr>
          <a:xfrm>
            <a:off x="375809" y="2074845"/>
            <a:ext cx="2875695" cy="563331"/>
          </a:xfrm>
          <a:prstGeom prst="rect">
            <a:avLst/>
          </a:prstGeom>
        </p:spPr>
      </p:pic>
      <p:sp>
        <p:nvSpPr>
          <p:cNvPr id="7" name="Rectangle 6"/>
          <p:cNvSpPr/>
          <p:nvPr/>
        </p:nvSpPr>
        <p:spPr>
          <a:xfrm>
            <a:off x="38103" y="6276589"/>
            <a:ext cx="6819897" cy="267765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/>
              <a:t>Supplemental Figure 2: </a:t>
            </a:r>
            <a:r>
              <a:rPr lang="en-US" sz="1400" b="1" dirty="0" err="1"/>
              <a:t>obASCs</a:t>
            </a:r>
            <a:r>
              <a:rPr lang="en-US" sz="1400" b="1" dirty="0"/>
              <a:t> promote metastasis, but not tumor growth of ER MUT </a:t>
            </a:r>
            <a:r>
              <a:rPr lang="en-US" sz="1400" b="1" dirty="0" err="1"/>
              <a:t>xenografts</a:t>
            </a:r>
            <a:r>
              <a:rPr lang="en-US" sz="1400" b="1" dirty="0"/>
              <a:t> in the presence of estrogen pellets. </a:t>
            </a:r>
            <a:endParaRPr lang="en-US" sz="1400" dirty="0"/>
          </a:p>
          <a:p>
            <a:r>
              <a:rPr lang="en-US" sz="1400" dirty="0"/>
              <a:t>A) Average tumor volume of ER MUT tumors (MCF7-Y537S and WHIM20 PDX) over the time course of the experiment is shown. Tumor growth is affected by culture with both ASCs in ER MUT MCF7-Y537S when estrogen is present and ASCs with estrogen in the WHIM20 model seem to inhibit tumor growth B) Metastatic index of </a:t>
            </a:r>
            <a:r>
              <a:rPr lang="en-US" sz="1400" dirty="0" err="1"/>
              <a:t>orthotopic</a:t>
            </a:r>
            <a:r>
              <a:rPr lang="en-US" sz="1400" dirty="0"/>
              <a:t> cell line </a:t>
            </a:r>
            <a:r>
              <a:rPr lang="en-US" sz="1400" dirty="0" err="1"/>
              <a:t>xenograft</a:t>
            </a:r>
            <a:r>
              <a:rPr lang="en-US" sz="1400" dirty="0"/>
              <a:t> and patient derived </a:t>
            </a:r>
            <a:r>
              <a:rPr lang="en-US" sz="1400" dirty="0" err="1"/>
              <a:t>xenograft</a:t>
            </a:r>
            <a:r>
              <a:rPr lang="en-US" sz="1400" dirty="0"/>
              <a:t> grown alone or with </a:t>
            </a:r>
            <a:r>
              <a:rPr lang="en-US" sz="1400" dirty="0" err="1"/>
              <a:t>lnASCs</a:t>
            </a:r>
            <a:r>
              <a:rPr lang="en-US" sz="1400" dirty="0"/>
              <a:t> or </a:t>
            </a:r>
            <a:r>
              <a:rPr lang="en-US" sz="1400" dirty="0" err="1"/>
              <a:t>obASCs</a:t>
            </a:r>
            <a:r>
              <a:rPr lang="en-US" sz="1400" dirty="0"/>
              <a:t> demonstrates a trend of increased metastasis in tumors grown with </a:t>
            </a:r>
            <a:r>
              <a:rPr lang="en-US" sz="1400" dirty="0" err="1"/>
              <a:t>obASCs</a:t>
            </a:r>
            <a:r>
              <a:rPr lang="en-US" sz="1400" dirty="0"/>
              <a:t>. C) Circulating tumor cell analysis of PDX groups demonstrates increased human (HLA1</a:t>
            </a:r>
            <a:r>
              <a:rPr lang="en-US" sz="1400" baseline="30000" dirty="0"/>
              <a:t>+</a:t>
            </a:r>
            <a:r>
              <a:rPr lang="en-US" sz="1400" dirty="0"/>
              <a:t>) circulating cells when tumors were grown with </a:t>
            </a:r>
            <a:r>
              <a:rPr lang="en-US" sz="1400" dirty="0" err="1"/>
              <a:t>obASCs</a:t>
            </a:r>
            <a:r>
              <a:rPr lang="en-US" sz="1400" dirty="0"/>
              <a:t> and increased human cancer stem cells (CD44</a:t>
            </a:r>
            <a:r>
              <a:rPr lang="en-US" sz="1400" baseline="30000" dirty="0"/>
              <a:t>+</a:t>
            </a:r>
            <a:r>
              <a:rPr lang="en-US" sz="1400" dirty="0"/>
              <a:t>CD24</a:t>
            </a:r>
            <a:r>
              <a:rPr lang="en-US" sz="1400" baseline="30000" dirty="0"/>
              <a:t>-</a:t>
            </a:r>
            <a:r>
              <a:rPr lang="en-US" sz="1400" dirty="0"/>
              <a:t>) circulating in mice with </a:t>
            </a:r>
            <a:r>
              <a:rPr lang="en-US" sz="1400" dirty="0" err="1"/>
              <a:t>PDX+obASCs</a:t>
            </a:r>
            <a:r>
              <a:rPr lang="en-US" sz="1400" dirty="0"/>
              <a:t>. Values reported are the mean </a:t>
            </a:r>
            <a:r>
              <a:rPr lang="en-US" sz="1400"/>
              <a:t>(</a:t>
            </a:r>
            <a:r>
              <a:rPr lang="en-US" sz="1400" smtClean="0"/>
              <a:t>n = 5 </a:t>
            </a:r>
            <a:r>
              <a:rPr lang="en-US" sz="1400" dirty="0"/>
              <a:t>mice/group). Bars, ± SEM. *p&lt;0.05, ** p&lt;0.01, ***p&lt;0.001.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0" y="-107316"/>
            <a:ext cx="37702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/>
              <a:t>A</a:t>
            </a:r>
            <a:endParaRPr lang="en-US" sz="2400" b="1" dirty="0"/>
          </a:p>
        </p:txBody>
      </p:sp>
      <p:sp>
        <p:nvSpPr>
          <p:cNvPr id="14" name="TextBox 13"/>
          <p:cNvSpPr txBox="1"/>
          <p:nvPr/>
        </p:nvSpPr>
        <p:spPr>
          <a:xfrm>
            <a:off x="0" y="2388985"/>
            <a:ext cx="35718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/>
              <a:t>B</a:t>
            </a:r>
            <a:endParaRPr lang="en-US" sz="2400" b="1" dirty="0"/>
          </a:p>
        </p:txBody>
      </p:sp>
      <p:sp>
        <p:nvSpPr>
          <p:cNvPr id="15" name="TextBox 14"/>
          <p:cNvSpPr txBox="1"/>
          <p:nvPr/>
        </p:nvSpPr>
        <p:spPr>
          <a:xfrm>
            <a:off x="0" y="4558706"/>
            <a:ext cx="34757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/>
              <a:t>C</a:t>
            </a:r>
            <a:endParaRPr lang="en-US" sz="2400" b="1" dirty="0"/>
          </a:p>
        </p:txBody>
      </p:sp>
    </p:spTree>
    <p:extLst>
      <p:ext uri="{BB962C8B-B14F-4D97-AF65-F5344CB8AC3E}">
        <p14:creationId xmlns:p14="http://schemas.microsoft.com/office/powerpoint/2010/main" val="264310138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1_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5</TotalTime>
  <Words>298</Words>
  <Application>Microsoft Office PowerPoint</Application>
  <PresentationFormat>Letter Paper (8.5x11 in)</PresentationFormat>
  <Paragraphs>8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1_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achel Sabol</dc:creator>
  <cp:lastModifiedBy>James Kemp</cp:lastModifiedBy>
  <cp:revision>2</cp:revision>
  <dcterms:created xsi:type="dcterms:W3CDTF">2019-01-29T21:42:11Z</dcterms:created>
  <dcterms:modified xsi:type="dcterms:W3CDTF">2019-03-18T14:51:58Z</dcterms:modified>
</cp:coreProperties>
</file>